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30" d="100"/>
          <a:sy n="130" d="100"/>
        </p:scale>
        <p:origin x="606" y="-156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A%20LUISA\Documents\Doctorado\Cecilia_Doctorado\Resultados\AUTOFAGIA-LAMP2-SE&#209;ALIZACION\media%20densitometrados%20cambiados%20de%20nuevo%201%202_4%20de%20octubre%202015_enero%202016_18%20enero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2691290018832563"/>
          <c:y val="6.9827167830437145E-2"/>
          <c:w val="0.71683003766479036"/>
          <c:h val="0.7157906049145486"/>
        </c:manualLayout>
      </c:layout>
      <c:barChart>
        <c:barDir val="col"/>
        <c:grouping val="clustered"/>
        <c:varyColors val="0"/>
        <c:ser>
          <c:idx val="0"/>
          <c:order val="0"/>
          <c:tx>
            <c:v>NSE</c:v>
          </c:tx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[1]0d 6d Time Course'!$S$20:$S$23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18000000000000024</c:v>
                  </c:pt>
                  <c:pt idx="2">
                    <c:v>0.23</c:v>
                  </c:pt>
                  <c:pt idx="3">
                    <c:v>0.1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6350"/>
            </c:spPr>
          </c:errBars>
          <c:cat>
            <c:strRef>
              <c:f>'0 6d time course'!$W$13:$W$16</c:f>
              <c:strCache>
                <c:ptCount val="4"/>
                <c:pt idx="0">
                  <c:v>C</c:v>
                </c:pt>
                <c:pt idx="1">
                  <c:v>2d</c:v>
                </c:pt>
                <c:pt idx="2">
                  <c:v>4d</c:v>
                </c:pt>
                <c:pt idx="3">
                  <c:v>6d</c:v>
                </c:pt>
              </c:strCache>
            </c:strRef>
          </c:cat>
          <c:val>
            <c:numRef>
              <c:f>'[1]0d 6d Time Course'!$R$20:$R$23</c:f>
              <c:numCache>
                <c:formatCode>General</c:formatCode>
                <c:ptCount val="4"/>
                <c:pt idx="0">
                  <c:v>1</c:v>
                </c:pt>
                <c:pt idx="1">
                  <c:v>1.8597106532222698</c:v>
                </c:pt>
                <c:pt idx="2">
                  <c:v>2.3288031565103031</c:v>
                </c:pt>
                <c:pt idx="3">
                  <c:v>2.995835160017536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9F5-4F4E-B0D3-33AA1C2A3F3A}"/>
            </c:ext>
          </c:extLst>
        </c:ser>
        <c:ser>
          <c:idx val="1"/>
          <c:order val="1"/>
          <c:tx>
            <c:v>bIII Tub</c:v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>
                  <a:lumMod val="50000"/>
                  <a:lumOff val="50000"/>
                </a:schemeClr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[1]0d 6d Time Course'!$U$20:$U$23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32000000000000156</c:v>
                  </c:pt>
                  <c:pt idx="2">
                    <c:v>0.60000000000000064</c:v>
                  </c:pt>
                  <c:pt idx="3">
                    <c:v>0.6000000000000006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6350"/>
            </c:spPr>
          </c:errBars>
          <c:cat>
            <c:strRef>
              <c:f>'0 6d time course'!$W$13:$W$16</c:f>
              <c:strCache>
                <c:ptCount val="4"/>
                <c:pt idx="0">
                  <c:v>C</c:v>
                </c:pt>
                <c:pt idx="1">
                  <c:v>2d</c:v>
                </c:pt>
                <c:pt idx="2">
                  <c:v>4d</c:v>
                </c:pt>
                <c:pt idx="3">
                  <c:v>6d</c:v>
                </c:pt>
              </c:strCache>
            </c:strRef>
          </c:cat>
          <c:val>
            <c:numRef>
              <c:f>'[1]0d 6d Time Course'!$T$20:$T$23</c:f>
              <c:numCache>
                <c:formatCode>General</c:formatCode>
                <c:ptCount val="4"/>
                <c:pt idx="0">
                  <c:v>1</c:v>
                </c:pt>
                <c:pt idx="1">
                  <c:v>3.2409845449341881</c:v>
                </c:pt>
                <c:pt idx="2">
                  <c:v>6.1053234115627015</c:v>
                </c:pt>
                <c:pt idx="3">
                  <c:v>6.77418431597023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9F5-4F4E-B0D3-33AA1C2A3F3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126015360"/>
        <c:axId val="126016896"/>
      </c:barChart>
      <c:catAx>
        <c:axId val="12601536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en-US" sz="10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26016896"/>
        <c:crosses val="autoZero"/>
        <c:auto val="1"/>
        <c:lblAlgn val="ctr"/>
        <c:lblOffset val="0"/>
        <c:noMultiLvlLbl val="0"/>
      </c:catAx>
      <c:valAx>
        <c:axId val="126016896"/>
        <c:scaling>
          <c:orientation val="minMax"/>
          <c:max val="8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en-US" sz="100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000">
                    <a:latin typeface="Arial" panose="020B0604020202020204" pitchFamily="34" charset="0"/>
                    <a:cs typeface="Arial" panose="020B0604020202020204" pitchFamily="34" charset="0"/>
                  </a:rPr>
                  <a:t>NE</a:t>
                </a:r>
                <a:r>
                  <a:rPr lang="en-US" sz="1000" baseline="0">
                    <a:latin typeface="Arial" panose="020B0604020202020204" pitchFamily="34" charset="0"/>
                    <a:cs typeface="Arial" panose="020B0604020202020204" pitchFamily="34" charset="0"/>
                  </a:rPr>
                  <a:t> markers</a:t>
                </a:r>
                <a:endParaRPr 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lang="en-US" sz="1000" b="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26015360"/>
        <c:crosses val="autoZero"/>
        <c:crossBetween val="between"/>
        <c:majorUnit val="2"/>
      </c:valAx>
      <c:spPr>
        <a:noFill/>
        <a:ln>
          <a:noFill/>
        </a:ln>
      </c:spPr>
    </c:plotArea>
    <c:legend>
      <c:legendPos val="r"/>
      <c:layout>
        <c:manualLayout>
          <c:xMode val="edge"/>
          <c:yMode val="edge"/>
          <c:x val="0.23682062146892655"/>
          <c:y val="7.2571666666666673E-2"/>
          <c:w val="0.22572316384180846"/>
          <c:h val="0.17496500000000093"/>
        </c:manualLayout>
      </c:layout>
      <c:overlay val="0"/>
      <c:txPr>
        <a:bodyPr/>
        <a:lstStyle/>
        <a:p>
          <a:pPr>
            <a:defRPr lang="en-US" sz="800">
              <a:latin typeface="Arial" panose="020B0604020202020204" pitchFamily="34" charset="0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FA8B5-CB9D-42A9-9D08-8D12520E6D04}" type="datetimeFigureOut">
              <a:rPr lang="es-ES" smtClean="0"/>
              <a:pPr/>
              <a:t>04/09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2C2A6-8C7F-4738-B38F-45EE33D533B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FA8B5-CB9D-42A9-9D08-8D12520E6D04}" type="datetimeFigureOut">
              <a:rPr lang="es-ES" smtClean="0"/>
              <a:pPr/>
              <a:t>04/09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2C2A6-8C7F-4738-B38F-45EE33D533B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FA8B5-CB9D-42A9-9D08-8D12520E6D04}" type="datetimeFigureOut">
              <a:rPr lang="es-ES" smtClean="0"/>
              <a:pPr/>
              <a:t>04/09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2C2A6-8C7F-4738-B38F-45EE33D533B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FA8B5-CB9D-42A9-9D08-8D12520E6D04}" type="datetimeFigureOut">
              <a:rPr lang="es-ES" smtClean="0"/>
              <a:pPr/>
              <a:t>04/09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2C2A6-8C7F-4738-B38F-45EE33D533B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FA8B5-CB9D-42A9-9D08-8D12520E6D04}" type="datetimeFigureOut">
              <a:rPr lang="es-ES" smtClean="0"/>
              <a:pPr/>
              <a:t>04/09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2C2A6-8C7F-4738-B38F-45EE33D533B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FA8B5-CB9D-42A9-9D08-8D12520E6D04}" type="datetimeFigureOut">
              <a:rPr lang="es-ES" smtClean="0"/>
              <a:pPr/>
              <a:t>04/09/2016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2C2A6-8C7F-4738-B38F-45EE33D533B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FA8B5-CB9D-42A9-9D08-8D12520E6D04}" type="datetimeFigureOut">
              <a:rPr lang="es-ES" smtClean="0"/>
              <a:pPr/>
              <a:t>04/09/2016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2C2A6-8C7F-4738-B38F-45EE33D533B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FA8B5-CB9D-42A9-9D08-8D12520E6D04}" type="datetimeFigureOut">
              <a:rPr lang="es-ES" smtClean="0"/>
              <a:pPr/>
              <a:t>04/09/2016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2C2A6-8C7F-4738-B38F-45EE33D533B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FA8B5-CB9D-42A9-9D08-8D12520E6D04}" type="datetimeFigureOut">
              <a:rPr lang="es-ES" smtClean="0"/>
              <a:pPr/>
              <a:t>04/09/2016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2C2A6-8C7F-4738-B38F-45EE33D533B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FA8B5-CB9D-42A9-9D08-8D12520E6D04}" type="datetimeFigureOut">
              <a:rPr lang="es-ES" smtClean="0"/>
              <a:pPr/>
              <a:t>04/09/2016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2C2A6-8C7F-4738-B38F-45EE33D533B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FA8B5-CB9D-42A9-9D08-8D12520E6D04}" type="datetimeFigureOut">
              <a:rPr lang="es-ES" smtClean="0"/>
              <a:pPr/>
              <a:t>04/09/2016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2C2A6-8C7F-4738-B38F-45EE33D533B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AFA8B5-CB9D-42A9-9D08-8D12520E6D04}" type="datetimeFigureOut">
              <a:rPr lang="es-ES" smtClean="0"/>
              <a:pPr/>
              <a:t>04/09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62C2A6-8C7F-4738-B38F-45EE33D533B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4 Grupo"/>
          <p:cNvGrpSpPr/>
          <p:nvPr/>
        </p:nvGrpSpPr>
        <p:grpSpPr>
          <a:xfrm>
            <a:off x="644615" y="1419938"/>
            <a:ext cx="2383486" cy="1721022"/>
            <a:chOff x="537991" y="267080"/>
            <a:chExt cx="2383486" cy="1837595"/>
          </a:xfrm>
        </p:grpSpPr>
        <p:pic>
          <p:nvPicPr>
            <p:cNvPr id="6" name="56 Imagen" descr="1 exp3 y 4 Diana rep TC NSE.tif"/>
            <p:cNvPicPr preferRelativeResize="0">
              <a:picLocks/>
            </p:cNvPicPr>
            <p:nvPr/>
          </p:nvPicPr>
          <p:blipFill>
            <a:blip r:embed="rId2" cstate="print">
              <a:lum bright="10000"/>
            </a:blip>
            <a:srcRect l="15672" t="64098" r="46449" b="18280"/>
            <a:stretch>
              <a:fillRect/>
            </a:stretch>
          </p:blipFill>
          <p:spPr bwMode="auto">
            <a:xfrm>
              <a:off x="1189521" y="746126"/>
              <a:ext cx="1722841" cy="397486"/>
            </a:xfrm>
            <a:prstGeom prst="rect">
              <a:avLst/>
            </a:prstGeom>
            <a:noFill/>
            <a:ln w="12700">
              <a:noFill/>
              <a:miter lim="800000"/>
              <a:headEnd/>
              <a:tailEnd/>
            </a:ln>
          </p:spPr>
        </p:pic>
        <p:pic>
          <p:nvPicPr>
            <p:cNvPr id="7" name="56 Imagen" descr="140220   TUBB3 time course.tif"/>
            <p:cNvPicPr preferRelativeResize="0">
              <a:picLocks/>
            </p:cNvPicPr>
            <p:nvPr/>
          </p:nvPicPr>
          <p:blipFill>
            <a:blip r:embed="rId3" cstate="print">
              <a:lum bright="10000"/>
            </a:blip>
            <a:srcRect l="44292" t="37756" r="18982" b="30025"/>
            <a:stretch>
              <a:fillRect/>
            </a:stretch>
          </p:blipFill>
          <p:spPr bwMode="auto">
            <a:xfrm>
              <a:off x="1198636" y="1216761"/>
              <a:ext cx="1722841" cy="399244"/>
            </a:xfrm>
            <a:prstGeom prst="rect">
              <a:avLst/>
            </a:prstGeom>
            <a:noFill/>
            <a:ln w="12700">
              <a:noFill/>
              <a:miter lim="800000"/>
              <a:headEnd/>
              <a:tailEnd/>
            </a:ln>
          </p:spPr>
        </p:pic>
        <p:pic>
          <p:nvPicPr>
            <p:cNvPr id="8" name="57 Imagen" descr="140220 time course GAPDH de TUBB3.tif"/>
            <p:cNvPicPr preferRelativeResize="0">
              <a:picLocks/>
            </p:cNvPicPr>
            <p:nvPr/>
          </p:nvPicPr>
          <p:blipFill>
            <a:blip r:embed="rId4" cstate="print">
              <a:lum bright="10000"/>
            </a:blip>
            <a:srcRect l="11073" t="68127" r="41982" b="22391"/>
            <a:stretch>
              <a:fillRect/>
            </a:stretch>
          </p:blipFill>
          <p:spPr bwMode="auto">
            <a:xfrm>
              <a:off x="1188003" y="1707189"/>
              <a:ext cx="1722841" cy="397486"/>
            </a:xfrm>
            <a:prstGeom prst="rect">
              <a:avLst/>
            </a:prstGeom>
            <a:noFill/>
            <a:ln w="12700">
              <a:noFill/>
              <a:miter lim="800000"/>
              <a:headEnd/>
              <a:tailEnd/>
            </a:ln>
          </p:spPr>
        </p:pic>
        <p:sp>
          <p:nvSpPr>
            <p:cNvPr id="9" name="8 CuadroTexto"/>
            <p:cNvSpPr txBox="1">
              <a:spLocks noChangeArrowheads="1"/>
            </p:cNvSpPr>
            <p:nvPr/>
          </p:nvSpPr>
          <p:spPr bwMode="auto">
            <a:xfrm>
              <a:off x="579418" y="798183"/>
              <a:ext cx="609600" cy="2628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>
                <a:defRPr/>
              </a:pPr>
              <a:r>
                <a:rPr lang="es-ES_tradnl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SE</a:t>
              </a:r>
              <a:endParaRPr lang="es-E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150 CuadroTexto"/>
            <p:cNvSpPr txBox="1">
              <a:spLocks noChangeArrowheads="1"/>
            </p:cNvSpPr>
            <p:nvPr/>
          </p:nvSpPr>
          <p:spPr bwMode="auto">
            <a:xfrm>
              <a:off x="537991" y="1266495"/>
              <a:ext cx="639919" cy="2628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r">
                <a:defRPr/>
              </a:pPr>
              <a:r>
                <a:rPr lang="el-G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s-E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II </a:t>
              </a:r>
              <a:r>
                <a:rPr lang="es-ES_tradnl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Tub</a:t>
              </a:r>
              <a:endParaRPr lang="es-E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53 CuadroTexto"/>
            <p:cNvSpPr txBox="1">
              <a:spLocks noChangeArrowheads="1"/>
            </p:cNvSpPr>
            <p:nvPr/>
          </p:nvSpPr>
          <p:spPr bwMode="auto">
            <a:xfrm>
              <a:off x="547435" y="1761795"/>
              <a:ext cx="647933" cy="2628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r">
                <a:defRPr/>
              </a:pPr>
              <a:r>
                <a:rPr lang="es-ES_tradnl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es-E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57 CuadroTexto"/>
            <p:cNvSpPr txBox="1">
              <a:spLocks noChangeArrowheads="1"/>
            </p:cNvSpPr>
            <p:nvPr/>
          </p:nvSpPr>
          <p:spPr bwMode="auto">
            <a:xfrm>
              <a:off x="1668475" y="527131"/>
              <a:ext cx="333746" cy="2628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_tradnl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2d</a:t>
              </a:r>
              <a:endParaRPr lang="es-E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58 CuadroTexto"/>
            <p:cNvSpPr txBox="1">
              <a:spLocks noChangeArrowheads="1"/>
            </p:cNvSpPr>
            <p:nvPr/>
          </p:nvSpPr>
          <p:spPr bwMode="auto">
            <a:xfrm>
              <a:off x="1282206" y="508829"/>
              <a:ext cx="277640" cy="2628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_tradnl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s-E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67 CuadroTexto"/>
            <p:cNvSpPr txBox="1">
              <a:spLocks noChangeArrowheads="1"/>
            </p:cNvSpPr>
            <p:nvPr/>
          </p:nvSpPr>
          <p:spPr bwMode="auto">
            <a:xfrm>
              <a:off x="2097103" y="500034"/>
              <a:ext cx="333746" cy="2628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4d</a:t>
              </a:r>
            </a:p>
          </p:txBody>
        </p:sp>
        <p:sp>
          <p:nvSpPr>
            <p:cNvPr id="15" name="71 CuadroTexto"/>
            <p:cNvSpPr txBox="1">
              <a:spLocks noChangeArrowheads="1"/>
            </p:cNvSpPr>
            <p:nvPr/>
          </p:nvSpPr>
          <p:spPr bwMode="auto">
            <a:xfrm>
              <a:off x="2493092" y="508829"/>
              <a:ext cx="333746" cy="2628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6d</a:t>
              </a:r>
            </a:p>
          </p:txBody>
        </p:sp>
        <p:cxnSp>
          <p:nvCxnSpPr>
            <p:cNvPr id="16" name="15 Conector recto"/>
            <p:cNvCxnSpPr/>
            <p:nvPr/>
          </p:nvCxnSpPr>
          <p:spPr bwMode="auto">
            <a:xfrm>
              <a:off x="1658918" y="527131"/>
              <a:ext cx="12065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CuadroTexto 17"/>
            <p:cNvSpPr txBox="1">
              <a:spLocks noChangeArrowheads="1"/>
            </p:cNvSpPr>
            <p:nvPr/>
          </p:nvSpPr>
          <p:spPr bwMode="auto">
            <a:xfrm>
              <a:off x="2049412" y="267080"/>
              <a:ext cx="348172" cy="2628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F</a:t>
              </a:r>
              <a:endParaRPr lang="es-E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9" name="48 Rectángulo"/>
          <p:cNvSpPr/>
          <p:nvPr/>
        </p:nvSpPr>
        <p:spPr>
          <a:xfrm>
            <a:off x="662058" y="3554397"/>
            <a:ext cx="5286412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 S1. Time course variation of NE marker proteins in LNCaP cells cultured in serum free medium.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LNCaP cells were grown in serum-containing medium (C) or serum-free medium (SF) for 2, 4  and 6 days. Thereafter cells were lysed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euroendocrine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rkers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, NSE and </a:t>
            </a:r>
            <a:r>
              <a:rPr lang="el-G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II </a:t>
            </a:r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ub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asured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hole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ysate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by Western </a:t>
            </a:r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lot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GAPDH </a:t>
            </a:r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as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sed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as a </a:t>
            </a:r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oading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control. </a:t>
            </a:r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nsitometric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smtClean="0">
                <a:latin typeface="Arial" panose="020B0604020202020204" pitchFamily="34" charset="0"/>
                <a:cs typeface="Arial" panose="020B0604020202020204" pitchFamily="34" charset="0"/>
              </a:rPr>
              <a:t>analysis 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Western </a:t>
            </a:r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lot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ands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are </a:t>
            </a:r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hown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n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ight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esults are the mean  ± S.D. of at least three independent (* p&lt;0.05 versus control cells compared by the Student’s t test).</a:t>
            </a:r>
          </a:p>
        </p:txBody>
      </p:sp>
      <p:grpSp>
        <p:nvGrpSpPr>
          <p:cNvPr id="26" name="25 Grupo"/>
          <p:cNvGrpSpPr/>
          <p:nvPr/>
        </p:nvGrpSpPr>
        <p:grpSpPr>
          <a:xfrm>
            <a:off x="3305264" y="1512709"/>
            <a:ext cx="2124000" cy="1916283"/>
            <a:chOff x="3305264" y="1512709"/>
            <a:chExt cx="2124000" cy="1916283"/>
          </a:xfrm>
        </p:grpSpPr>
        <p:grpSp>
          <p:nvGrpSpPr>
            <p:cNvPr id="18" name="Group 4"/>
            <p:cNvGrpSpPr/>
            <p:nvPr/>
          </p:nvGrpSpPr>
          <p:grpSpPr>
            <a:xfrm>
              <a:off x="3305264" y="1512709"/>
              <a:ext cx="2124000" cy="1916283"/>
              <a:chOff x="2730587" y="495477"/>
              <a:chExt cx="2124000" cy="1916283"/>
            </a:xfrm>
          </p:grpSpPr>
          <p:cxnSp>
            <p:nvCxnSpPr>
              <p:cNvPr id="19" name="18 Conector recto"/>
              <p:cNvCxnSpPr/>
              <p:nvPr/>
            </p:nvCxnSpPr>
            <p:spPr bwMode="auto">
              <a:xfrm>
                <a:off x="3667232" y="2197330"/>
                <a:ext cx="1044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CuadroTexto 17"/>
              <p:cNvSpPr txBox="1">
                <a:spLocks noChangeArrowheads="1"/>
              </p:cNvSpPr>
              <p:nvPr/>
            </p:nvSpPr>
            <p:spPr bwMode="auto">
              <a:xfrm>
                <a:off x="4022821" y="2165539"/>
                <a:ext cx="304892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s-ES" sz="1000" b="1" dirty="0" smtClean="0"/>
                  <a:t>SF</a:t>
                </a:r>
                <a:endParaRPr lang="es-ES" sz="1000" b="1" dirty="0"/>
              </a:p>
            </p:txBody>
          </p:sp>
          <p:graphicFrame>
            <p:nvGraphicFramePr>
              <p:cNvPr id="21" name="1 Gráfico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828690737"/>
                  </p:ext>
                </p:extLst>
              </p:nvPr>
            </p:nvGraphicFramePr>
            <p:xfrm>
              <a:off x="2730587" y="495477"/>
              <a:ext cx="2124000" cy="1800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</p:grpSp>
        <p:sp>
          <p:nvSpPr>
            <p:cNvPr id="22" name="21 CuadroTexto"/>
            <p:cNvSpPr txBox="1"/>
            <p:nvPr/>
          </p:nvSpPr>
          <p:spPr bwMode="auto">
            <a:xfrm>
              <a:off x="4315719" y="2230569"/>
              <a:ext cx="224742" cy="215444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s-E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3" name="22 CuadroTexto"/>
            <p:cNvSpPr txBox="1"/>
            <p:nvPr/>
          </p:nvSpPr>
          <p:spPr bwMode="auto">
            <a:xfrm>
              <a:off x="4696641" y="1714480"/>
              <a:ext cx="224742" cy="215444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s-E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4" name="23 CuadroTexto"/>
            <p:cNvSpPr txBox="1"/>
            <p:nvPr/>
          </p:nvSpPr>
          <p:spPr bwMode="auto">
            <a:xfrm>
              <a:off x="5085514" y="1611359"/>
              <a:ext cx="224742" cy="215444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s-E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5" name="24 CuadroTexto"/>
            <p:cNvSpPr txBox="1"/>
            <p:nvPr/>
          </p:nvSpPr>
          <p:spPr bwMode="auto">
            <a:xfrm>
              <a:off x="4944453" y="2292926"/>
              <a:ext cx="224742" cy="215444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s-E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3</TotalTime>
  <Words>128</Words>
  <Application>Microsoft Office PowerPoint</Application>
  <PresentationFormat>Presentación en pantalla (4:3)</PresentationFormat>
  <Paragraphs>15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2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4" baseType="lpstr">
      <vt:lpstr>Arial</vt:lpstr>
      <vt:lpstr>Calibri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Nieves</dc:creator>
  <cp:lastModifiedBy>Rodríguez Henche Nieves</cp:lastModifiedBy>
  <cp:revision>15</cp:revision>
  <dcterms:created xsi:type="dcterms:W3CDTF">2016-02-16T15:19:42Z</dcterms:created>
  <dcterms:modified xsi:type="dcterms:W3CDTF">2016-09-04T19:48:05Z</dcterms:modified>
</cp:coreProperties>
</file>